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931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631D84-DD4E-4F62-B790-AAD9D2FA19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E8C290-6970-469E-9505-154197DDC9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FBB48-297F-4648-999B-CDFAD866E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19F769-8FDC-4D2E-8D4E-1D514CCC7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216C6D-7F5D-427A-9F43-26F18BB3B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988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1A263-61F0-4CDF-B44C-53CC1F9940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FE1C01-565C-4247-A5F8-0D0C424F34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3034FA-2711-4C94-81EA-C1171F2EE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78DDAF-5D7A-4E9D-B3C4-784295EC0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BCB0C-7AAB-4C3E-BD0B-138669C7F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5857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90877EC-CA67-430C-BF52-D8C6D8CE15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2B09FB-4C1C-42FF-9909-E8957CD81F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A1F50E-03A0-4D32-BC51-63EF7BE21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910567-2746-46EA-99E0-9539756B1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F9760C-E914-41B2-8387-7A42C8270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0840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9A7819-541D-41CB-A9FE-1F1BEEDDD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9185B6-7869-4274-A09F-4C2B91CB8D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ABFC4E-82CF-4CD8-95B2-5F331D675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3FCDAE-21BF-4B93-B0B0-CE7786C55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0F2F4D-729A-4E17-8A0F-EBBF2B1F4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6884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CE38BC-4748-4CAE-91E9-FC25C5AA0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7BBA2C-1825-42F9-A902-2AEDEB2505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909C62-15EA-4440-B87B-9B2037266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F106EF-DFAE-43FB-9F7D-7D91C2124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BF185-4410-460F-B94C-214357EBA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202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B7DCD3-DABF-4AE1-BE77-59DE569CD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CCD4B4-5A9F-4EA1-98EC-11926DE9CE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CD59BC-746E-4918-B215-6279DF6B42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42118C-4B58-4F24-946C-E38B6E1C7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5DC056-219E-4BD2-BF29-2C364B35C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FF9E7F-66D3-443B-B75A-551B050D9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198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D7C728-D143-41AA-ADD6-453ADD126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7F5C2E-5487-4B11-BC47-F29F83DD94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73828C-9913-4677-95E9-D1D69B4034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148E523-627D-42DA-8FC2-8216115A28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3A4E54-1496-4B2F-9B19-22BE1FC6AB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BE07F34-3B4B-4D1C-84DE-F9BBA44B17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62BBB45-464B-4F15-AE11-7BB0F6B32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0ADE15-8445-4DC8-A033-820BDA7AE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5418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4125C-187D-4235-925D-E40EA2571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4BB091-4580-4578-A60B-E94730157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FD2887-2651-4723-BD61-E7CEE9BA5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4C6F48-549C-4578-9406-246B11F4B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5810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F196CB-B44C-47AB-BCFD-4CA992CC4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6B7CC0-6A62-41D8-B3E9-2DCB9E141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7D702F-64D4-4D04-8CC0-AF0A2B63B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0940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428E8A-8D6E-4F1E-83A8-F89748565D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38D3B7-1A7E-4F97-A080-4CC8B8112D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3A2C67-2FCA-456F-87DD-E6E61BEC5A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1A1841-29B0-472E-8184-F06526E8E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743165-E08A-4556-BF6B-62C7CBFF0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A326EE-74A1-4199-BEC5-88386D694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758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F6AC8B-E144-49B3-9B16-FD9D71B50E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95E83B3-0E18-44B2-8256-E7DCFB756B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EEF79A-6124-4889-B36B-C1CAA61B85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39C718-5512-40C6-884A-7CA651E516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311678-91F9-4222-98D9-3DFB101A2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4826DD-307E-4E4D-8EDB-AA71A13CF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0774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0DC5CF-247E-44AF-B445-18A59A1AC5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A3AEB3-9A21-461B-AF6C-58E06B29BB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FB95E1-6417-40B9-A00B-351DF24825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58BF8F-542F-4F92-A745-4368C88FA908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229DC2-F8C0-485E-972E-CD43894EED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D704EA-D214-44AF-B3E6-F58BA4CFC2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883F1B-DF42-4AC9-AC21-A92B4E00D2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6454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C5BCBB0-C706-4C13-9878-B60785EAF862}"/>
              </a:ext>
            </a:extLst>
          </p:cNvPr>
          <p:cNvSpPr txBox="1"/>
          <p:nvPr/>
        </p:nvSpPr>
        <p:spPr>
          <a:xfrm>
            <a:off x="748404" y="3972560"/>
            <a:ext cx="1069519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. 1 | Compounds used, their protein targets, and other relevant information. 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table shows the compounds used in screening experiments at the denoted concentrations, and their respective protein targets shown to be expressed in the human embryonic stem cell-derived cardiomyocytes (hESC-CMs) cell model, as well as adult cardiomyocytes. Concentrations used in the hESC-CM screen were chosen based on the </a:t>
            </a:r>
            <a:r>
              <a:rPr lang="en-GB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C</a:t>
            </a:r>
            <a:r>
              <a:rPr lang="en-GB" sz="18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values reported in literature or on IUPHAR/BPS Guide to PHARMACOLOGY (https://www.guidetopharmacology.org).</a:t>
            </a:r>
          </a:p>
          <a:p>
            <a:endParaRPr lang="en-GB" dirty="0"/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AA721775-48BE-4E55-8F93-AC8BC62505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4575975"/>
              </p:ext>
            </p:extLst>
          </p:nvPr>
        </p:nvGraphicFramePr>
        <p:xfrm>
          <a:off x="2615088" y="1470819"/>
          <a:ext cx="6961823" cy="1300734"/>
        </p:xfrm>
        <a:graphic>
          <a:graphicData uri="http://schemas.openxmlformats.org/drawingml/2006/table">
            <a:tbl>
              <a:tblPr firstRow="1"/>
              <a:tblGrid>
                <a:gridCol w="1265042">
                  <a:extLst>
                    <a:ext uri="{9D8B030D-6E8A-4147-A177-3AD203B41FA5}">
                      <a16:colId xmlns:a16="http://schemas.microsoft.com/office/drawing/2014/main" val="3693114225"/>
                    </a:ext>
                  </a:extLst>
                </a:gridCol>
                <a:gridCol w="1533329">
                  <a:extLst>
                    <a:ext uri="{9D8B030D-6E8A-4147-A177-3AD203B41FA5}">
                      <a16:colId xmlns:a16="http://schemas.microsoft.com/office/drawing/2014/main" val="36695018"/>
                    </a:ext>
                  </a:extLst>
                </a:gridCol>
                <a:gridCol w="2873855">
                  <a:extLst>
                    <a:ext uri="{9D8B030D-6E8A-4147-A177-3AD203B41FA5}">
                      <a16:colId xmlns:a16="http://schemas.microsoft.com/office/drawing/2014/main" val="3179371611"/>
                    </a:ext>
                  </a:extLst>
                </a:gridCol>
                <a:gridCol w="1289597">
                  <a:extLst>
                    <a:ext uri="{9D8B030D-6E8A-4147-A177-3AD203B41FA5}">
                      <a16:colId xmlns:a16="http://schemas.microsoft.com/office/drawing/2014/main" val="4007930794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ound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rget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c. used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A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8482627"/>
                  </a:ext>
                </a:extLst>
              </a:tr>
              <a:tr h="18351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mostat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MPRSS2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mall molecule inhibitor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 μM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8322618"/>
                  </a:ext>
                </a:extLst>
              </a:tr>
              <a:tr h="19240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nztropine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1400" baseline="30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US" sz="14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1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mall molecule inhibitor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 μM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078338"/>
                  </a:ext>
                </a:extLst>
              </a:tr>
              <a:tr h="18351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64d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hepsin B/L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mall molecule inhibitor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 μM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6858423"/>
                  </a:ext>
                </a:extLst>
              </a:tr>
              <a:tr h="19240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X600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E2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ptide inhibitor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 μM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612665"/>
                  </a:ext>
                </a:extLst>
              </a:tr>
              <a:tr h="18351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E2 ab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E2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lyclonal antibody (neutralizing)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 </a:t>
                      </a:r>
                      <a:r>
                        <a:rPr lang="en-US" sz="14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μg</a:t>
                      </a:r>
                      <a:r>
                        <a:rPr lang="en-US" sz="14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mL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1373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84323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40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Williams</dc:creator>
  <cp:lastModifiedBy>Tom Williams</cp:lastModifiedBy>
  <cp:revision>1</cp:revision>
  <dcterms:created xsi:type="dcterms:W3CDTF">2021-01-21T09:36:20Z</dcterms:created>
  <dcterms:modified xsi:type="dcterms:W3CDTF">2021-01-21T09:38:24Z</dcterms:modified>
</cp:coreProperties>
</file>